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84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EB14-A0DA-413C-BD32-B9A1E1CB7E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2CCC96-8401-4069-8042-B2E78C532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01E0E8-1514-4EE2-BCA8-838D4DA45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29414-5F59-4239-BD45-6D0594B10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380BD-C3EC-4DEF-B9E2-BC4DEAA0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F395F-1BB3-454B-A518-0F8F178E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C5102D-2272-47AD-BA73-D93A0CD03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544D5-EFF4-4F7E-9319-2AC3ACB57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C522B-6F38-4837-9777-3126D4398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25A47-E766-4651-AAAC-2FA5D797B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98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5A0FC7-B943-4666-85CE-1FE5D92555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EBD3F-6810-4137-985D-3FDC57B1A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8989B-7726-431D-82E1-23F570411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6C540-003E-4498-BE58-D455765BC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BDD52-5E18-4363-A930-4D77328E6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21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AA6D2-7570-4076-B479-A6B9BEAD9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C61CD1-7ECB-4216-9D11-CF8D7728AC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1CAB2-5D88-4C00-9B1B-E3F5364DA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50248-645A-4032-A470-A0819B91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A465F6-B1B9-4D11-B36B-78A67B8AA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07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D5746-FAF3-483E-8BB4-78567C1CD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E50D08-8948-4AC6-8556-7435ED4D8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659B8-8040-490A-B1BB-D0FE4C18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566E5-280D-4E67-BCB1-1D018FB2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09A0A-09B7-42A7-A1C2-7DB1DAA3B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170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4CEF9-1257-47D5-A187-EA505A0C8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3D7EF2-577A-4A4A-862B-03FA1A63D5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F01A57-A7D1-48EC-A2EC-6406C4FCD7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A4CE64-EBE6-495E-A77C-5D7CBF148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B6676-166D-475A-9B2E-2E8245262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9B28C-F500-4F3A-9BAB-C4F11159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00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A2923-741A-46E1-80BD-6F43A7411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812135-4947-49B4-A511-19ED2E602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27C3A8-D54C-4CC8-9031-E19F5194EE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29DFBC-40B5-4CE3-8AB3-34111107C0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24113-FED6-4F38-B272-115E7A1FDD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60AFAB-5A3B-4809-9767-327AA79C9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621F0E-D8F3-4CA4-AAAA-B7D1C6DE9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A3F71E-D8EE-496E-8BB4-7251EC1D0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1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A1C7D-DD09-4648-BC83-3DA39B7F7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6893-7D2D-4EF9-8EB4-A346499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AE66F7-FF3A-4C56-B145-BBE3CDF0A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03D9AB-787F-45EE-958F-338D84402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5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5EE8ED-27C7-4D6C-A022-CE76D8035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92EA3-D8F1-460E-812B-F48079876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66240-9AF3-499B-B263-417B89D24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542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92915-37EB-4C88-8BB1-1AB1420FE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E5F16-8BED-4C7B-B071-4CD5D847E1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8CD66-CE7D-4F13-9A17-A17DCCC9C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81079-4924-49D5-8346-465287211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FEFA4-7A71-480E-92F0-8C14442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BD7BA-0F90-40D2-A98E-C08E1DC5D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19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B292-F8BD-4395-95F6-9A400B4CA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EFA1A3-21B2-48A0-8980-62FF3A5AF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E64A9-EE47-4397-B748-E0EF85A2A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B340C-6BB6-4C9D-AAEB-8A83A8D4F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32CB6-E7DC-4516-B7E5-3FBD0E36D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67DEE-120E-47AD-A372-3AB014499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87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7AF786-A348-4E78-86E4-8D5D45D2A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CF09E-FD97-4DF4-84A4-54582CE023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C8C0F-43BD-47D8-A6C2-FE7163C752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8B26-E781-4484-950D-EB55FD3B01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6DE0F-8290-477F-9C5F-84EF8CDD5A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2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DE8428A-C88F-43C3-B7C0-E571E03EE00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80" t="980"/>
          <a:stretch/>
        </p:blipFill>
        <p:spPr>
          <a:xfrm>
            <a:off x="8935655" y="277792"/>
            <a:ext cx="2988593" cy="19764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847E286-295B-46E8-A39A-568517B4638C}"/>
              </a:ext>
            </a:extLst>
          </p:cNvPr>
          <p:cNvSpPr txBox="1"/>
          <p:nvPr/>
        </p:nvSpPr>
        <p:spPr>
          <a:xfrm>
            <a:off x="5948624" y="160774"/>
            <a:ext cx="1871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: LTH vs. GTH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3071ACCA-1B23-490F-8B02-0F1805D157D4}"/>
              </a:ext>
            </a:extLst>
          </p:cNvPr>
          <p:cNvCxnSpPr/>
          <p:nvPr/>
        </p:nvCxnSpPr>
        <p:spPr>
          <a:xfrm flipH="1" flipV="1">
            <a:off x="7819777" y="1256233"/>
            <a:ext cx="1586690" cy="2762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>
            <a:extLst>
              <a:ext uri="{FF2B5EF4-FFF2-40B4-BE49-F238E27FC236}">
                <a16:creationId xmlns:a16="http://schemas.microsoft.com/office/drawing/2014/main" id="{E876B217-DD3B-4B71-8F79-08CCAC43A0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6934" y="3767021"/>
            <a:ext cx="5994399" cy="29972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B81C0A2-3438-4E89-A177-4B33BBAC71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224" y="160774"/>
            <a:ext cx="7543800" cy="3771900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B604B26-096D-4C91-A1E9-435F5F4489FB}"/>
              </a:ext>
            </a:extLst>
          </p:cNvPr>
          <p:cNvCxnSpPr/>
          <p:nvPr/>
        </p:nvCxnSpPr>
        <p:spPr>
          <a:xfrm flipH="1">
            <a:off x="4504267" y="690880"/>
            <a:ext cx="6587066" cy="6929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itle 1">
            <a:extLst>
              <a:ext uri="{FF2B5EF4-FFF2-40B4-BE49-F238E27FC236}">
                <a16:creationId xmlns:a16="http://schemas.microsoft.com/office/drawing/2014/main" id="{74A0BA2A-3918-1F4B-AC71-0FF07AFF8FED}"/>
              </a:ext>
            </a:extLst>
          </p:cNvPr>
          <p:cNvSpPr txBox="1">
            <a:spLocks/>
          </p:cNvSpPr>
          <p:nvPr/>
        </p:nvSpPr>
        <p:spPr>
          <a:xfrm>
            <a:off x="0" y="-88145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Supplemental Figure 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E9D5630-8F4D-A943-9132-FD72BB34122D}"/>
              </a:ext>
            </a:extLst>
          </p:cNvPr>
          <p:cNvSpPr txBox="1"/>
          <p:nvPr/>
        </p:nvSpPr>
        <p:spPr>
          <a:xfrm>
            <a:off x="2278673" y="310030"/>
            <a:ext cx="355433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lected biological pathways in males for each time grou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708F83-9C7B-8449-AC2E-52E3F76D6913}"/>
              </a:ext>
            </a:extLst>
          </p:cNvPr>
          <p:cNvSpPr txBox="1"/>
          <p:nvPr/>
        </p:nvSpPr>
        <p:spPr>
          <a:xfrm>
            <a:off x="6295122" y="3765348"/>
            <a:ext cx="359802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ological pathways common to both time groups of male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FDE808-D627-C945-AEBA-D7FDB3C0EE5D}"/>
              </a:ext>
            </a:extLst>
          </p:cNvPr>
          <p:cNvSpPr txBox="1"/>
          <p:nvPr/>
        </p:nvSpPr>
        <p:spPr>
          <a:xfrm>
            <a:off x="8094133" y="198360"/>
            <a:ext cx="12682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le samples ≥ 60 days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E0BEC86-5A02-0848-959F-08BA507B7D92}"/>
              </a:ext>
            </a:extLst>
          </p:cNvPr>
          <p:cNvSpPr txBox="1"/>
          <p:nvPr/>
        </p:nvSpPr>
        <p:spPr>
          <a:xfrm>
            <a:off x="11462853" y="203142"/>
            <a:ext cx="863379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le samples &lt; 60 days 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69DCF5E-9BA5-488B-AA1D-790AC6921C35}"/>
              </a:ext>
            </a:extLst>
          </p:cNvPr>
          <p:cNvCxnSpPr>
            <a:cxnSpLocks/>
          </p:cNvCxnSpPr>
          <p:nvPr/>
        </p:nvCxnSpPr>
        <p:spPr>
          <a:xfrm flipH="1">
            <a:off x="9893144" y="1464733"/>
            <a:ext cx="774856" cy="24679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8920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2</cp:revision>
  <dcterms:created xsi:type="dcterms:W3CDTF">2022-05-12T17:09:25Z</dcterms:created>
  <dcterms:modified xsi:type="dcterms:W3CDTF">2022-05-12T17:10:20Z</dcterms:modified>
</cp:coreProperties>
</file>